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69"/>
    <p:restoredTop sz="95728"/>
  </p:normalViewPr>
  <p:slideViewPr>
    <p:cSldViewPr snapToGrid="0" snapToObjects="1">
      <p:cViewPr varScale="1">
        <p:scale>
          <a:sx n="106" d="100"/>
          <a:sy n="106" d="100"/>
        </p:scale>
        <p:origin x="192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>
            <a:extLst>
              <a:ext uri="{FF2B5EF4-FFF2-40B4-BE49-F238E27FC236}">
                <a16:creationId xmlns:a16="http://schemas.microsoft.com/office/drawing/2014/main" id="{FA07D207-96A1-4948-96D4-9F3AC1E820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5167" y="1351345"/>
            <a:ext cx="2438335" cy="2438335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11BA8464-62A8-E14C-B199-2560FCBE63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955" y="1351345"/>
            <a:ext cx="2427641" cy="2438335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E85382C9-784D-F643-A8CE-2B1662BDC7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8956" y="3857167"/>
            <a:ext cx="2433052" cy="2438400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BF1B9BFC-7398-4440-BEA6-E30638742D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89755" y="3857167"/>
            <a:ext cx="2443747" cy="24384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o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not lead to hyperplasia or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umorigenesi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but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tentia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Gh 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release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D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localisatio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and Ki-67 in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7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2795167" y="3864229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268955" y="3864229"/>
            <a:ext cx="157767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-67 </a:t>
            </a:r>
          </a:p>
          <a:p>
            <a:r>
              <a:rPr lang="fr-FR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</a:t>
            </a:r>
            <a:r>
              <a:rPr lang="fr-FR" sz="11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2785668" y="1356049"/>
            <a:ext cx="244783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1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1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268955" y="1377167"/>
            <a:ext cx="9444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(</a:t>
            </a:r>
            <a:r>
              <a:rPr lang="fr-FR" sz="11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1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A091BE7-7575-6E4E-A30D-B5E989C1ABA3}"/>
              </a:ext>
            </a:extLst>
          </p:cNvPr>
          <p:cNvSpPr/>
          <p:nvPr/>
        </p:nvSpPr>
        <p:spPr>
          <a:xfrm>
            <a:off x="5431308" y="2396594"/>
            <a:ext cx="6096000" cy="132343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</a:t>
            </a:r>
            <a:r>
              <a:rPr lang="en-US" sz="1600" u="sng" dirty="0" err="1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h</a:t>
            </a:r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nterior pituitary)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goat anti-GH (R&amp;D systems, Cat. No AF1067-SP, dilution 1:133) antibody 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anti-</a:t>
            </a: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at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exa Fluor 488 </a:t>
            </a: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cam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Cat. No ab150129, dilution 1:200) </a:t>
            </a: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431308" y="1369160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431308" y="4125839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Ki-67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rabbit polyclonal anti-Ki-67 antibody (Merck, Cat. No AB9260) (dilution 1:300) </a:t>
            </a:r>
            <a:endParaRPr lang="fr-BE" sz="1600" dirty="0">
              <a:solidFill>
                <a:srgbClr val="FF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rabbit IgG (H+L) F(ab’)2 fragment Alexa Fluor 647 conjugate (Cell Signaling Technology, Cat. No 4414, dilution 1:1000) </a:t>
            </a:r>
            <a:endParaRPr lang="fr-BE" sz="1600" dirty="0">
              <a:solidFill>
                <a:srgbClr val="FF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197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14</cp:revision>
  <dcterms:created xsi:type="dcterms:W3CDTF">2020-05-09T12:35:08Z</dcterms:created>
  <dcterms:modified xsi:type="dcterms:W3CDTF">2020-05-25T21:00:34Z</dcterms:modified>
</cp:coreProperties>
</file>